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81" r:id="rId2"/>
    <p:sldId id="256" r:id="rId3"/>
    <p:sldId id="257" r:id="rId4"/>
    <p:sldId id="258" r:id="rId5"/>
    <p:sldId id="260" r:id="rId6"/>
    <p:sldId id="259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/>
    <p:restoredTop sz="94674"/>
  </p:normalViewPr>
  <p:slideViewPr>
    <p:cSldViewPr snapToGrid="0" snapToObjects="1">
      <p:cViewPr varScale="1">
        <p:scale>
          <a:sx n="59" d="100"/>
          <a:sy n="59" d="100"/>
        </p:scale>
        <p:origin x="147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91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329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83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86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648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404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649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939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554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920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794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33C92-60E6-4040-A661-23484B2C3EF7}" type="datetimeFigureOut">
              <a:rPr lang="en-US" smtClean="0"/>
              <a:t>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EFF97-4412-DD46-BDB0-50877E2C6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703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0A3AE07-D6E9-464F-A16B-2EE1EF3C7C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688336"/>
              </p:ext>
            </p:extLst>
          </p:nvPr>
        </p:nvGraphicFramePr>
        <p:xfrm>
          <a:off x="108203" y="1487424"/>
          <a:ext cx="6641593" cy="59512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343844">
                  <a:extLst>
                    <a:ext uri="{9D8B030D-6E8A-4147-A177-3AD203B41FA5}">
                      <a16:colId xmlns:a16="http://schemas.microsoft.com/office/drawing/2014/main" val="4015141673"/>
                    </a:ext>
                  </a:extLst>
                </a:gridCol>
                <a:gridCol w="2355055">
                  <a:extLst>
                    <a:ext uri="{9D8B030D-6E8A-4147-A177-3AD203B41FA5}">
                      <a16:colId xmlns:a16="http://schemas.microsoft.com/office/drawing/2014/main" val="541518328"/>
                    </a:ext>
                  </a:extLst>
                </a:gridCol>
                <a:gridCol w="2942694">
                  <a:extLst>
                    <a:ext uri="{9D8B030D-6E8A-4147-A177-3AD203B41FA5}">
                      <a16:colId xmlns:a16="http://schemas.microsoft.com/office/drawing/2014/main" val="251617559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Oligo Name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Sequence (5’-3’)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Purpose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493057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-F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</a:rPr>
                        <a:t>tgcaGTTGGTCTTTGCTCCTGC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nneal to mak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 for the OsBiP1-Cas9-tRNA syst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198764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-F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</a:rPr>
                        <a:t>gcagGTTGGTCTTTGCTCCTGC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nneal to mak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 for the OsBiP1-Cas9-Csy4 system and mini 35s-enhancer-Cas9-Csy4 syst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6693650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-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</a:rPr>
                        <a:t>aaacCTGCAGGAGCAAAGACCAA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nneal to mak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7349612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-F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</a:rPr>
                        <a:t>tgcaATGAGCTGCAAGAACAATT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nneal to mak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 for the OsBiP1-Cas9-tRNA syst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1204425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-F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cagATGAGCTGCAAGAACAAT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nneal to mak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 for the OsBiP1-Cas9-Csy4 system and mini 35s-enhancer-Cas9-Csy4 syst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2172781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-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 err="1">
                          <a:effectLst/>
                        </a:rPr>
                        <a:t>aaacCAATTGTTCTTGCAGCTCA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nneal to mak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4247274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OsPDS-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AGGCAACATGTCACTTGGCTCTAG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mplifying th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 target si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0968432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R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CTCCACTACAGACTGAGCACAAAGCTT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mplifying th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 target si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8990564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F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TAGTCCAGGGATGTAATCATC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mplifying th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 target si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1264239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CAGTTGCACTGGGACTTG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mplifying the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 target si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8828593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Cas9-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HTS-F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GCAACATGTCACTTGGC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High-throughput sequencing primer without barcode for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 si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1799406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Cas9-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HTS-R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CGCTCTTGCAAAATGTC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High-throughput sequencing primer without barcode for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PDS</a:t>
                      </a:r>
                      <a:r>
                        <a:rPr lang="en-US" sz="1200" u="none" strike="noStrike" dirty="0">
                          <a:effectLst/>
                        </a:rPr>
                        <a:t>-sgRNA01 si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827488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Cas9-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HTS-F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GCGGCTGAAATTACATGTAGAAA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High-throughput sequencing primer without barcode for 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 si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9320393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Cas9-</a:t>
                      </a:r>
                      <a:r>
                        <a:rPr lang="en-US" sz="12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HTS-R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ACAGGAGCACGAGCAGTT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High-throughput sequencing primer without barcode for </a:t>
                      </a:r>
                      <a:r>
                        <a:rPr lang="en-US" sz="1200" i="1" u="none" strike="noStrike" dirty="0">
                          <a:effectLst/>
                        </a:rPr>
                        <a:t>OsDEP1</a:t>
                      </a:r>
                      <a:r>
                        <a:rPr lang="en-US" sz="1200" u="none" strike="noStrike" dirty="0">
                          <a:effectLst/>
                        </a:rPr>
                        <a:t>-sgRNA01 si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400030356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4D6F0594-378A-447A-B673-ECA76D767E73}"/>
              </a:ext>
            </a:extLst>
          </p:cNvPr>
          <p:cNvSpPr/>
          <p:nvPr/>
        </p:nvSpPr>
        <p:spPr>
          <a:xfrm>
            <a:off x="0" y="1009180"/>
            <a:ext cx="674979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/>
              <a:t>Supplemental Table 1. Oligos used in this study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70984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3ADF81E-9610-41F5-8F89-20D1B6F3939F}"/>
              </a:ext>
            </a:extLst>
          </p:cNvPr>
          <p:cNvSpPr txBox="1"/>
          <p:nvPr/>
        </p:nvSpPr>
        <p:spPr>
          <a:xfrm>
            <a:off x="248285" y="466090"/>
            <a:ext cx="5247640" cy="4154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mini 35s-enhancer-Cas9-csy4::</a:t>
            </a:r>
            <a:r>
              <a:rPr lang="en-US" altLang="zh-CN" sz="1200" i="1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OsPDS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sgRNA01</a:t>
            </a:r>
          </a:p>
          <a:p>
            <a:endParaRPr lang="en-US" altLang="zh-CN" sz="12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  <a:sym typeface="+mn-ea"/>
            </a:endParaRPr>
          </a:p>
          <a:p>
            <a:r>
              <a:rPr lang="en-US" altLang="zh-CN" sz="1200" i="1" dirty="0" err="1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OsPDS</a:t>
            </a:r>
            <a:r>
              <a:rPr lang="en-US" altLang="zh-CN" sz="1200" dirty="0" err="1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_WT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   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-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4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-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WT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+1bp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5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+1bp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+1bp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13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+1bp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+1bp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17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-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WT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+1bp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20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+1bp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TG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+1bp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28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GCTCC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-CAG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GGGT  -1bp</a:t>
            </a:r>
          </a:p>
          <a:p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CTGGA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GGTCTTT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en-US" altLang="zh-CN" sz="12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altLang="zh-CN" sz="12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</a:t>
            </a:r>
            <a:r>
              <a:rPr lang="en-US" altLang="zh-CN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-------</a:t>
            </a:r>
            <a:r>
              <a:rPr lang="en-US" altLang="zh-CN" sz="12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altLang="zh-CN" sz="12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31bp     </a:t>
            </a:r>
          </a:p>
          <a:p>
            <a:endParaRPr lang="en-US" altLang="zh-CN" sz="12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" name="文本框 2">
            <a:extLst>
              <a:ext uri="{FF2B5EF4-FFF2-40B4-BE49-F238E27FC236}">
                <a16:creationId xmlns:a16="http://schemas.microsoft.com/office/drawing/2014/main" id="{73A61F1B-47A3-4B76-8A62-A20555DE1672}"/>
              </a:ext>
            </a:extLst>
          </p:cNvPr>
          <p:cNvSpPr txBox="1"/>
          <p:nvPr/>
        </p:nvSpPr>
        <p:spPr>
          <a:xfrm>
            <a:off x="248284" y="4572000"/>
            <a:ext cx="65208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tx1"/>
                </a:solidFill>
              </a:rPr>
              <a:t>Figure S1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4888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5DDDBFF-FD38-4BD0-9877-406F7EF95E3D}"/>
              </a:ext>
            </a:extLst>
          </p:cNvPr>
          <p:cNvSpPr txBox="1"/>
          <p:nvPr/>
        </p:nvSpPr>
        <p:spPr>
          <a:xfrm>
            <a:off x="518021" y="1988687"/>
            <a:ext cx="4576022" cy="46320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OsBiP1-Cas9-tRNA::</a:t>
            </a:r>
            <a:r>
              <a:rPr lang="en-US" altLang="zh-CN" sz="1000" i="1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OsDEP1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sgRNA01</a:t>
            </a:r>
          </a:p>
          <a:p>
            <a:r>
              <a:rPr lang="en-US" altLang="zh-CN" sz="1000" i="1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OsDEP1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_WT:  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A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1</a:t>
            </a:r>
            <a:r>
              <a:rPr lang="zh-CN" altLang="en-US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：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#2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4</a:t>
            </a:r>
            <a:r>
              <a:rPr lang="zh-CN" altLang="en-US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：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5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3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6</a:t>
            </a:r>
            <a:r>
              <a:rPr lang="zh-CN" altLang="en-US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：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t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+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7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8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9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10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A-TT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CACCTTGGT   WT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5E51E01-A45F-4645-8820-5B23A1BDB90A}"/>
              </a:ext>
            </a:extLst>
          </p:cNvPr>
          <p:cNvGrpSpPr/>
          <p:nvPr/>
        </p:nvGrpSpPr>
        <p:grpSpPr>
          <a:xfrm>
            <a:off x="543421" y="482309"/>
            <a:ext cx="4702175" cy="1412875"/>
            <a:chOff x="594221" y="221590"/>
            <a:chExt cx="4702175" cy="1412875"/>
          </a:xfrm>
        </p:grpSpPr>
        <p:sp>
          <p:nvSpPr>
            <p:cNvPr id="5" name="文本框 2">
              <a:extLst>
                <a:ext uri="{FF2B5EF4-FFF2-40B4-BE49-F238E27FC236}">
                  <a16:creationId xmlns:a16="http://schemas.microsoft.com/office/drawing/2014/main" id="{31F8BA6B-8F76-478F-8E70-40FF4EB5C089}"/>
                </a:ext>
              </a:extLst>
            </p:cNvPr>
            <p:cNvSpPr txBox="1"/>
            <p:nvPr/>
          </p:nvSpPr>
          <p:spPr>
            <a:xfrm>
              <a:off x="1030784" y="251753"/>
              <a:ext cx="520700" cy="2746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ea typeface="宋体" panose="02010600030101010101" pitchFamily="2" charset="-122"/>
                </a:rPr>
                <a:t>WT</a:t>
              </a:r>
            </a:p>
          </p:txBody>
        </p:sp>
        <p:cxnSp>
          <p:nvCxnSpPr>
            <p:cNvPr id="6" name="直接连接符 3">
              <a:extLst>
                <a:ext uri="{FF2B5EF4-FFF2-40B4-BE49-F238E27FC236}">
                  <a16:creationId xmlns:a16="http://schemas.microsoft.com/office/drawing/2014/main" id="{AA0B0CC8-6847-4D31-B75D-1FEE7C098F47}"/>
                </a:ext>
              </a:extLst>
            </p:cNvPr>
            <p:cNvCxnSpPr/>
            <p:nvPr/>
          </p:nvCxnSpPr>
          <p:spPr>
            <a:xfrm>
              <a:off x="965696" y="520040"/>
              <a:ext cx="719138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37">
              <a:extLst>
                <a:ext uri="{FF2B5EF4-FFF2-40B4-BE49-F238E27FC236}">
                  <a16:creationId xmlns:a16="http://schemas.microsoft.com/office/drawing/2014/main" id="{3BA5EB27-4B85-4C2D-AB41-5A7C3C3A49FF}"/>
                </a:ext>
              </a:extLst>
            </p:cNvPr>
            <p:cNvSpPr txBox="1"/>
            <p:nvPr/>
          </p:nvSpPr>
          <p:spPr>
            <a:xfrm>
              <a:off x="954584" y="496228"/>
              <a:ext cx="290512" cy="3365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600" b="1">
                  <a:latin typeface="Arial" panose="020B0604020202020204" pitchFamily="34" charset="0"/>
                  <a:ea typeface="宋体" panose="02010600030101010101" pitchFamily="2" charset="-122"/>
                </a:rPr>
                <a:t>-</a:t>
              </a:r>
            </a:p>
          </p:txBody>
        </p:sp>
        <p:sp>
          <p:nvSpPr>
            <p:cNvPr id="8" name="文本框 38">
              <a:extLst>
                <a:ext uri="{FF2B5EF4-FFF2-40B4-BE49-F238E27FC236}">
                  <a16:creationId xmlns:a16="http://schemas.microsoft.com/office/drawing/2014/main" id="{A2DC94FD-4679-4A13-B7E5-700A84E66F10}"/>
                </a:ext>
              </a:extLst>
            </p:cNvPr>
            <p:cNvSpPr txBox="1"/>
            <p:nvPr/>
          </p:nvSpPr>
          <p:spPr>
            <a:xfrm>
              <a:off x="1299071" y="496228"/>
              <a:ext cx="323850" cy="3381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600">
                  <a:latin typeface="Arial" panose="020B0604020202020204" pitchFamily="34" charset="0"/>
                  <a:ea typeface="宋体" panose="02010600030101010101" pitchFamily="2" charset="-122"/>
                </a:rPr>
                <a:t>+</a:t>
              </a:r>
            </a:p>
          </p:txBody>
        </p:sp>
        <p:sp>
          <p:nvSpPr>
            <p:cNvPr id="9" name="文本框 49">
              <a:extLst>
                <a:ext uri="{FF2B5EF4-FFF2-40B4-BE49-F238E27FC236}">
                  <a16:creationId xmlns:a16="http://schemas.microsoft.com/office/drawing/2014/main" id="{C0A52D67-F86B-4046-BB63-276896E19882}"/>
                </a:ext>
              </a:extLst>
            </p:cNvPr>
            <p:cNvSpPr txBox="1"/>
            <p:nvPr/>
          </p:nvSpPr>
          <p:spPr>
            <a:xfrm>
              <a:off x="594221" y="562903"/>
              <a:ext cx="465138" cy="246062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pPr algn="ctr"/>
              <a:r>
                <a:rPr lang="en-US" altLang="zh-CN" sz="1000" i="1" dirty="0" err="1">
                  <a:latin typeface="Arial" panose="020B0604020202020204" pitchFamily="34" charset="0"/>
                  <a:ea typeface="宋体" panose="02010600030101010101" pitchFamily="2" charset="-122"/>
                </a:rPr>
                <a:t>MfeI</a:t>
              </a:r>
              <a:endParaRPr lang="en-US" altLang="zh-CN" sz="1000" i="1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0" name="文本框 4">
              <a:extLst>
                <a:ext uri="{FF2B5EF4-FFF2-40B4-BE49-F238E27FC236}">
                  <a16:creationId xmlns:a16="http://schemas.microsoft.com/office/drawing/2014/main" id="{73728FBA-7E0F-4FCF-9C17-DC1C4BCE230A}"/>
                </a:ext>
              </a:extLst>
            </p:cNvPr>
            <p:cNvSpPr txBox="1"/>
            <p:nvPr/>
          </p:nvSpPr>
          <p:spPr>
            <a:xfrm>
              <a:off x="1648321" y="545440"/>
              <a:ext cx="3559175" cy="24447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ea typeface="宋体" panose="02010600030101010101" pitchFamily="2" charset="-122"/>
                </a:rPr>
                <a:t>  1        2        3        4        5        6        7        8        9       10</a:t>
              </a:r>
            </a:p>
          </p:txBody>
        </p:sp>
        <p:cxnSp>
          <p:nvCxnSpPr>
            <p:cNvPr id="11" name="直接连接符 8">
              <a:extLst>
                <a:ext uri="{FF2B5EF4-FFF2-40B4-BE49-F238E27FC236}">
                  <a16:creationId xmlns:a16="http://schemas.microsoft.com/office/drawing/2014/main" id="{B7C26E98-510A-499D-8D88-0F2130410703}"/>
                </a:ext>
              </a:extLst>
            </p:cNvPr>
            <p:cNvCxnSpPr/>
            <p:nvPr/>
          </p:nvCxnSpPr>
          <p:spPr>
            <a:xfrm>
              <a:off x="1740396" y="520040"/>
              <a:ext cx="33956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2">
              <a:extLst>
                <a:ext uri="{FF2B5EF4-FFF2-40B4-BE49-F238E27FC236}">
                  <a16:creationId xmlns:a16="http://schemas.microsoft.com/office/drawing/2014/main" id="{2CD82C66-4D71-4C2C-822F-E1644EAC6C49}"/>
                </a:ext>
              </a:extLst>
            </p:cNvPr>
            <p:cNvSpPr txBox="1"/>
            <p:nvPr/>
          </p:nvSpPr>
          <p:spPr>
            <a:xfrm>
              <a:off x="1978013" y="221590"/>
              <a:ext cx="2900819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pPr algn="ctr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rPr>
                <a:t>OsBiP1-Cas9-tRNA-</a:t>
              </a:r>
              <a:r>
                <a:rPr lang="en-US" altLang="zh-CN" sz="1200" i="1" dirty="0">
                  <a:latin typeface="Arial" panose="020B0604020202020204" pitchFamily="34" charset="0"/>
                  <a:ea typeface="宋体" panose="02010600030101010101" pitchFamily="2" charset="-122"/>
                </a:rPr>
                <a:t>OsDEP1</a:t>
              </a:r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rPr>
                <a:t>-gRNA01</a:t>
              </a:r>
            </a:p>
          </p:txBody>
        </p:sp>
        <p:pic>
          <p:nvPicPr>
            <p:cNvPr id="13" name="图片 5">
              <a:extLst>
                <a:ext uri="{FF2B5EF4-FFF2-40B4-BE49-F238E27FC236}">
                  <a16:creationId xmlns:a16="http://schemas.microsoft.com/office/drawing/2014/main" id="{36F18618-183F-43E6-B0D7-80E74B635D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/>
            <a:srcRect r="26501"/>
            <a:stretch>
              <a:fillRect/>
            </a:stretch>
          </p:blipFill>
          <p:spPr>
            <a:xfrm>
              <a:off x="606921" y="762928"/>
              <a:ext cx="4689475" cy="871537"/>
            </a:xfrm>
            <a:prstGeom prst="rect">
              <a:avLst/>
            </a:prstGeom>
            <a:noFill/>
            <a:ln w="9525">
              <a:noFill/>
            </a:ln>
          </p:spPr>
        </p:pic>
      </p:grpSp>
      <p:sp>
        <p:nvSpPr>
          <p:cNvPr id="14" name="文本框 12">
            <a:extLst>
              <a:ext uri="{FF2B5EF4-FFF2-40B4-BE49-F238E27FC236}">
                <a16:creationId xmlns:a16="http://schemas.microsoft.com/office/drawing/2014/main" id="{9BBE065A-F9B8-42AC-A7E2-22E55C303198}"/>
              </a:ext>
            </a:extLst>
          </p:cNvPr>
          <p:cNvSpPr txBox="1"/>
          <p:nvPr/>
        </p:nvSpPr>
        <p:spPr>
          <a:xfrm>
            <a:off x="556121" y="6702426"/>
            <a:ext cx="6127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tx1"/>
                </a:solidFill>
              </a:rPr>
              <a:t>Figure S2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0DEF2DD-C6DA-1E41-AF93-08F4A8CDBAC8}"/>
              </a:ext>
            </a:extLst>
          </p:cNvPr>
          <p:cNvSpPr txBox="1"/>
          <p:nvPr/>
        </p:nvSpPr>
        <p:spPr>
          <a:xfrm>
            <a:off x="318212" y="409495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D64DBC7-CBBC-B64A-BEA1-F81318782023}"/>
              </a:ext>
            </a:extLst>
          </p:cNvPr>
          <p:cNvSpPr txBox="1"/>
          <p:nvPr/>
        </p:nvSpPr>
        <p:spPr>
          <a:xfrm>
            <a:off x="279616" y="1936923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5518722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1F4C203-52B6-4B0A-A69C-D11C73789A2D}"/>
              </a:ext>
            </a:extLst>
          </p:cNvPr>
          <p:cNvSpPr txBox="1"/>
          <p:nvPr/>
        </p:nvSpPr>
        <p:spPr>
          <a:xfrm>
            <a:off x="562219" y="2064067"/>
            <a:ext cx="4896544" cy="50937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OsBiP1-Cas9-csy4::</a:t>
            </a:r>
            <a:r>
              <a:rPr lang="en-US" altLang="zh-CN" sz="1000" i="1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OsDEP1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sgRNA01</a:t>
            </a:r>
          </a:p>
          <a:p>
            <a:r>
              <a:rPr lang="en-US" altLang="zh-CN" sz="1000" i="1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OsDEP1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_WT:  CAGC</a:t>
            </a:r>
            <a:r>
              <a:rPr lang="en-US" altLang="zh-CN" sz="100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A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1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2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A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WT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3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A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WT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</a:t>
            </a:r>
            <a:r>
              <a:rPr lang="en-US" altLang="zh-CN" sz="1000" dirty="0"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-------------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-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-</a:t>
            </a:r>
            <a:r>
              <a:rPr lang="en-US" altLang="zh-CN" sz="1000" dirty="0"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-------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   -60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4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 err="1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 err="1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A</a:t>
            </a:r>
            <a:r>
              <a:rPr lang="en-US" altLang="zh-CN" sz="1000" u="sng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</a:t>
            </a:r>
            <a:r>
              <a:rPr lang="en-US" altLang="zh-CN" sz="1000" u="sng" dirty="0" err="1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TTG</a:t>
            </a:r>
            <a:r>
              <a:rPr lang="en-US" altLang="zh-CN" sz="1000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 err="1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   +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5</a:t>
            </a:r>
            <a:r>
              <a:rPr lang="zh-CN" altLang="en-US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：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#6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7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3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g</a:t>
            </a:r>
            <a:r>
              <a:rPr lang="en-US" altLang="zh-CN" sz="1000" u="sng" dirty="0" err="1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 err="1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 err="1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   -3bp,+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8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3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2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9: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#10</a:t>
            </a: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1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  <a:endParaRPr lang="en-US" altLang="zh-CN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lele2:    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GC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TGAGCTGCAAGAACA</a:t>
            </a:r>
            <a:r>
              <a:rPr lang="en-US" altLang="zh-CN" sz="1000" u="sng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</a:t>
            </a:r>
            <a:r>
              <a:rPr lang="en-US" altLang="zh-CN" sz="1000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-TTG</a:t>
            </a:r>
            <a:r>
              <a:rPr lang="en-US" altLang="zh-CN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AGG</a:t>
            </a:r>
            <a:r>
              <a:rPr lang="en-US" altLang="zh-CN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  <a:sym typeface="+mn-ea"/>
              </a:rPr>
              <a:t>CACCTTGGT   -1bp</a:t>
            </a:r>
          </a:p>
        </p:txBody>
      </p:sp>
      <p:pic>
        <p:nvPicPr>
          <p:cNvPr id="5" name="图片 7">
            <a:extLst>
              <a:ext uri="{FF2B5EF4-FFF2-40B4-BE49-F238E27FC236}">
                <a16:creationId xmlns:a16="http://schemas.microsoft.com/office/drawing/2014/main" id="{F1DC02C9-4D4C-48B3-AFA2-138CD0D36DD0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rcRect r="26277"/>
          <a:stretch>
            <a:fillRect/>
          </a:stretch>
        </p:blipFill>
        <p:spPr>
          <a:xfrm>
            <a:off x="620192" y="1025207"/>
            <a:ext cx="4689475" cy="97536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6" name="文本框 2">
            <a:extLst>
              <a:ext uri="{FF2B5EF4-FFF2-40B4-BE49-F238E27FC236}">
                <a16:creationId xmlns:a16="http://schemas.microsoft.com/office/drawing/2014/main" id="{8C6D9D25-6CFD-4737-9438-1B02AAFDD25A}"/>
              </a:ext>
            </a:extLst>
          </p:cNvPr>
          <p:cNvSpPr txBox="1"/>
          <p:nvPr/>
        </p:nvSpPr>
        <p:spPr>
          <a:xfrm>
            <a:off x="1011035" y="504190"/>
            <a:ext cx="520700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1200">
                <a:latin typeface="Arial" panose="020B0604020202020204" pitchFamily="34" charset="0"/>
                <a:ea typeface="宋体" panose="02010600030101010101" pitchFamily="2" charset="-122"/>
              </a:rPr>
              <a:t>WT</a:t>
            </a:r>
          </a:p>
        </p:txBody>
      </p:sp>
      <p:cxnSp>
        <p:nvCxnSpPr>
          <p:cNvPr id="7" name="直接连接符 4">
            <a:extLst>
              <a:ext uri="{FF2B5EF4-FFF2-40B4-BE49-F238E27FC236}">
                <a16:creationId xmlns:a16="http://schemas.microsoft.com/office/drawing/2014/main" id="{83CCC905-E8B4-40C6-9186-BBB2A73A86C0}"/>
              </a:ext>
            </a:extLst>
          </p:cNvPr>
          <p:cNvCxnSpPr/>
          <p:nvPr/>
        </p:nvCxnSpPr>
        <p:spPr>
          <a:xfrm>
            <a:off x="945947" y="772477"/>
            <a:ext cx="719138" cy="0"/>
          </a:xfrm>
          <a:prstGeom prst="line">
            <a:avLst/>
          </a:prstGeom>
          <a:ln w="12700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37">
            <a:extLst>
              <a:ext uri="{FF2B5EF4-FFF2-40B4-BE49-F238E27FC236}">
                <a16:creationId xmlns:a16="http://schemas.microsoft.com/office/drawing/2014/main" id="{79DDA181-7018-4111-B8D9-07EB82AB466B}"/>
              </a:ext>
            </a:extLst>
          </p:cNvPr>
          <p:cNvSpPr txBox="1"/>
          <p:nvPr/>
        </p:nvSpPr>
        <p:spPr>
          <a:xfrm>
            <a:off x="934835" y="748665"/>
            <a:ext cx="290512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1600" b="1">
                <a:latin typeface="Arial" panose="020B0604020202020204" pitchFamily="34" charset="0"/>
                <a:ea typeface="宋体" panose="02010600030101010101" pitchFamily="2" charset="-122"/>
              </a:rPr>
              <a:t>-</a:t>
            </a:r>
          </a:p>
        </p:txBody>
      </p:sp>
      <p:sp>
        <p:nvSpPr>
          <p:cNvPr id="9" name="文本框 38">
            <a:extLst>
              <a:ext uri="{FF2B5EF4-FFF2-40B4-BE49-F238E27FC236}">
                <a16:creationId xmlns:a16="http://schemas.microsoft.com/office/drawing/2014/main" id="{E92B986D-E25B-4EF3-ADCD-8A74F5FB99A8}"/>
              </a:ext>
            </a:extLst>
          </p:cNvPr>
          <p:cNvSpPr txBox="1"/>
          <p:nvPr/>
        </p:nvSpPr>
        <p:spPr>
          <a:xfrm>
            <a:off x="1279322" y="748665"/>
            <a:ext cx="323850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+</a:t>
            </a:r>
          </a:p>
        </p:txBody>
      </p:sp>
      <p:sp>
        <p:nvSpPr>
          <p:cNvPr id="10" name="文本框 49">
            <a:extLst>
              <a:ext uri="{FF2B5EF4-FFF2-40B4-BE49-F238E27FC236}">
                <a16:creationId xmlns:a16="http://schemas.microsoft.com/office/drawing/2014/main" id="{E299C2B3-2396-4135-BA5B-1353C820C6CE}"/>
              </a:ext>
            </a:extLst>
          </p:cNvPr>
          <p:cNvSpPr txBox="1"/>
          <p:nvPr/>
        </p:nvSpPr>
        <p:spPr>
          <a:xfrm>
            <a:off x="574472" y="797560"/>
            <a:ext cx="465138" cy="246062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pPr algn="ctr"/>
            <a:r>
              <a:rPr lang="en-US" altLang="zh-CN" sz="1000" i="1" dirty="0" err="1">
                <a:latin typeface="Arial" panose="020B0604020202020204" pitchFamily="34" charset="0"/>
                <a:ea typeface="宋体" panose="02010600030101010101" pitchFamily="2" charset="-122"/>
              </a:rPr>
              <a:t>MfeI</a:t>
            </a:r>
            <a:endParaRPr lang="en-US" altLang="zh-CN" sz="1000" i="1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1" name="文本框 4">
            <a:extLst>
              <a:ext uri="{FF2B5EF4-FFF2-40B4-BE49-F238E27FC236}">
                <a16:creationId xmlns:a16="http://schemas.microsoft.com/office/drawing/2014/main" id="{3DDD926E-87B3-4B6F-ADB3-61C36A65A260}"/>
              </a:ext>
            </a:extLst>
          </p:cNvPr>
          <p:cNvSpPr txBox="1"/>
          <p:nvPr/>
        </p:nvSpPr>
        <p:spPr>
          <a:xfrm>
            <a:off x="1628572" y="797877"/>
            <a:ext cx="3559175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r>
              <a:rPr lang="en-US" altLang="zh-CN" sz="1000">
                <a:latin typeface="Arial" panose="020B0604020202020204" pitchFamily="34" charset="0"/>
                <a:ea typeface="宋体" panose="02010600030101010101" pitchFamily="2" charset="-122"/>
              </a:rPr>
              <a:t>  1        2        3        4        5        6        7        8        9       10</a:t>
            </a:r>
          </a:p>
        </p:txBody>
      </p:sp>
      <p:cxnSp>
        <p:nvCxnSpPr>
          <p:cNvPr id="12" name="直接连接符 9">
            <a:extLst>
              <a:ext uri="{FF2B5EF4-FFF2-40B4-BE49-F238E27FC236}">
                <a16:creationId xmlns:a16="http://schemas.microsoft.com/office/drawing/2014/main" id="{24A33EFD-6819-4E7B-AFA7-8B7C6467FB44}"/>
              </a:ext>
            </a:extLst>
          </p:cNvPr>
          <p:cNvCxnSpPr/>
          <p:nvPr/>
        </p:nvCxnSpPr>
        <p:spPr>
          <a:xfrm>
            <a:off x="1720647" y="772477"/>
            <a:ext cx="339566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2">
            <a:extLst>
              <a:ext uri="{FF2B5EF4-FFF2-40B4-BE49-F238E27FC236}">
                <a16:creationId xmlns:a16="http://schemas.microsoft.com/office/drawing/2014/main" id="{54E42A09-EB80-4822-8645-67924224FFB3}"/>
              </a:ext>
            </a:extLst>
          </p:cNvPr>
          <p:cNvSpPr txBox="1"/>
          <p:nvPr/>
        </p:nvSpPr>
        <p:spPr>
          <a:xfrm>
            <a:off x="1945183" y="501828"/>
            <a:ext cx="2877836" cy="276999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</a:rPr>
              <a:t>OsBiP1-Cas9-Csy4-</a:t>
            </a:r>
            <a:r>
              <a:rPr lang="en-US" altLang="zh-CN" sz="1200" i="1" dirty="0">
                <a:latin typeface="Arial" panose="020B0604020202020204" pitchFamily="34" charset="0"/>
                <a:ea typeface="宋体" panose="02010600030101010101" pitchFamily="2" charset="-122"/>
              </a:rPr>
              <a:t>OsDEP1</a:t>
            </a:r>
            <a:r>
              <a:rPr lang="en-US" altLang="zh-CN" sz="1200" dirty="0">
                <a:latin typeface="Arial" panose="020B0604020202020204" pitchFamily="34" charset="0"/>
                <a:ea typeface="宋体" panose="02010600030101010101" pitchFamily="2" charset="-122"/>
              </a:rPr>
              <a:t>-gRNA01</a:t>
            </a:r>
          </a:p>
        </p:txBody>
      </p:sp>
      <p:sp>
        <p:nvSpPr>
          <p:cNvPr id="14" name="文本框 12">
            <a:extLst>
              <a:ext uri="{FF2B5EF4-FFF2-40B4-BE49-F238E27FC236}">
                <a16:creationId xmlns:a16="http://schemas.microsoft.com/office/drawing/2014/main" id="{EDCB1373-3530-4DB4-92E8-1B71B059359A}"/>
              </a:ext>
            </a:extLst>
          </p:cNvPr>
          <p:cNvSpPr txBox="1"/>
          <p:nvPr/>
        </p:nvSpPr>
        <p:spPr>
          <a:xfrm>
            <a:off x="562219" y="7239123"/>
            <a:ext cx="59228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tx1"/>
                </a:solidFill>
              </a:rPr>
              <a:t>Figure S3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D23A836-C2CB-FD45-8AE8-1894C359E17E}"/>
              </a:ext>
            </a:extLst>
          </p:cNvPr>
          <p:cNvSpPr txBox="1"/>
          <p:nvPr/>
        </p:nvSpPr>
        <p:spPr>
          <a:xfrm>
            <a:off x="318212" y="409495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DDBE67C-A68A-6C47-8080-EFD13D2FB57B}"/>
              </a:ext>
            </a:extLst>
          </p:cNvPr>
          <p:cNvSpPr txBox="1"/>
          <p:nvPr/>
        </p:nvSpPr>
        <p:spPr>
          <a:xfrm>
            <a:off x="279616" y="1936923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8215529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2">
            <a:extLst>
              <a:ext uri="{FF2B5EF4-FFF2-40B4-BE49-F238E27FC236}">
                <a16:creationId xmlns:a16="http://schemas.microsoft.com/office/drawing/2014/main" id="{D1DC32C2-F6BD-46B1-AD60-DCF72CE72553}"/>
              </a:ext>
            </a:extLst>
          </p:cNvPr>
          <p:cNvSpPr/>
          <p:nvPr/>
        </p:nvSpPr>
        <p:spPr>
          <a:xfrm>
            <a:off x="265317" y="310207"/>
            <a:ext cx="6327366" cy="2191694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just">
              <a:lnSpc>
                <a:spcPts val="1600"/>
              </a:lnSpc>
              <a:spcAft>
                <a:spcPts val="600"/>
              </a:spcAft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&gt;Arabidopsis enhancer (At Chr4:17183498..17184077)</a:t>
            </a:r>
          </a:p>
          <a:p>
            <a:pPr algn="just">
              <a:lnSpc>
                <a:spcPts val="1600"/>
              </a:lnSpc>
            </a:pPr>
            <a:r>
              <a:rPr lang="en-US" altLang="zh-CN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GTCTTGGGAACAAGCGAAAGATCGAAACTCCGACAGACGTAATCTTAATTCGCTGAGAGGCGTGTGAGAATTGCCTTTTTCCTTGAATATAAAATGCACTCCCATAATGTAATCAAACAAAAGATATAAATAGAATAAGAAAAATAACAACTCAGCGTAACGGAGTCCGATTAACGGAGTGAGAAATCATCTGGTTTCTCGAGAGTTCTAAGCCAATGATAATCGAAGGAAACGAACGGTGTTGTGTGTGTGTGGTTAAGAAAAGAACAAACTCATACGAGACACGTGCACCGAAGCTTTTTCCCACGTGCCAAAGAGTTTCGTCTTCGTTCACACAGAACCAAGATGGGTGGTAACGAAGGTAGGACCCTAAAGCACCAGCCTACAACACATAGATGAAATAGTATATGCGTTTACATGGATTTGATGAATTGTTGTGTTTAGTATATAAGTATATTGTTTAGAATTATCAAAAAGTATACTTTATAAAAAGAGTGGTGGTAACATATTTAGTTTCTGCACCAATATAAAAAGAAATATGGTGATGTCTAAAGAAAAAAGAGAGAAAACTTAGCCACCA</a:t>
            </a:r>
            <a:endParaRPr lang="zh-CN" alt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文本框 12">
            <a:extLst>
              <a:ext uri="{FF2B5EF4-FFF2-40B4-BE49-F238E27FC236}">
                <a16:creationId xmlns:a16="http://schemas.microsoft.com/office/drawing/2014/main" id="{19A9E691-DB7B-4B8C-96A5-C1CAC57EAD29}"/>
              </a:ext>
            </a:extLst>
          </p:cNvPr>
          <p:cNvSpPr txBox="1"/>
          <p:nvPr/>
        </p:nvSpPr>
        <p:spPr>
          <a:xfrm>
            <a:off x="265317" y="2524501"/>
            <a:ext cx="61999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/>
              <a:t>Figure S4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24987443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2">
            <a:extLst>
              <a:ext uri="{FF2B5EF4-FFF2-40B4-BE49-F238E27FC236}">
                <a16:creationId xmlns:a16="http://schemas.microsoft.com/office/drawing/2014/main" id="{D1DC32C2-F6BD-46B1-AD60-DCF72CE72553}"/>
              </a:ext>
            </a:extLst>
          </p:cNvPr>
          <p:cNvSpPr/>
          <p:nvPr/>
        </p:nvSpPr>
        <p:spPr>
          <a:xfrm>
            <a:off x="265317" y="310207"/>
            <a:ext cx="6327366" cy="76277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600"/>
              </a:lnSpc>
              <a:spcAft>
                <a:spcPts val="600"/>
              </a:spcAft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&gt;OsBiP1 (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Os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hr2:25453280..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455516)</a:t>
            </a:r>
          </a:p>
          <a:p>
            <a:pPr algn="just">
              <a:lnSpc>
                <a:spcPts val="1600"/>
              </a:lnSpc>
            </a:pPr>
            <a:r>
              <a:rPr lang="en-US" altLang="zh-CN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AGCTGCAAACATAACAAATATACCTCAGAATCAATAAACTAGGCTAAAAGGGAACTGAAGAGAATCAACAGACTGTAGTCTCTGAGCAGTAACTACACAAAAACATATGATAGAACAATCTGGTAAAAACATATGCAGTATGTTCTACACCACAAATTTATTACATACAACAATTACATCTATCAGCGTGAAGAACGCATGTCAAATAGTTTCTTTCAATTTTTCATACACCAAAACAAAATTCATGGGCTAAAACCCCAAGACTTTAAATTGCATAAATACTGACAAGTGGCAACAAAAGCTGATTTTAAGGGTATGTAAACCTACCAGTAAGGTGGACGTTGACAGGGCAAACAAATTAGAATTTTGCACTGATACTAAAATGGGCTTCCAAACCCTAATAGGCACTAGATCAGACTGCACACACATACAACTACTAATGGGAAAACTAGGTCAGCATATACATTCAACGCCGTAAATTGGCATAGAAAACTTCATCATCACAGATGAAACCAAGCAGCTTGTATTTCTTATGTGGTTATAAAGGGGAGCACTTGCCATTGCTGTTACAAGACATACATTTATGTAGATTAATAATGATTTTCCATGGAATCCACAAGCATTTGTAAGCGAAAACGAAGCAAACATTACAAAATTCCCAAGTATCACTAAAGCAGAATAGCAGATGCAAGTAACATGGCACCTATTAGTAACCTAAGCCGTAGCAAACTTCACACTCCACGTCTCCAGAACAAATAAAAGCTCTGCAACGACCTAAAGTTATGCGAAAAGTGCAAAATCCCCAACAAGCGCCACTTCGTCATGTGAACCGAACCAGCCAAAATCTCAAACCTCCCCTCCCCTTCTCGATTCTCATAACGCAATAGAAGTATAGAGAAGGGATTGCTTCACGGGACGCACCTTTGATCCCGAGGGACGTCTGGCCGGATCCGACCGCGGTGAGCGCGTGCTCGATCTGCACCAGCTTCCCCGACGGGCTGCAAACGAAATCGCCACAAAAACCACAGATGACGAAACCGAAACCGCACCAGATCACGCCCGATCTCCGGGCGAGGGAGGCGCAAGGCAGCACATACCTGAAGGTGGTGAGGGAGAAGGAGTACTGGCTGTCTCCCATGGCCGCCGACGCGCAGGCCTACCTGTGAGCTGCTGCTCTTCGTGTCTCGCGGCGGAAGAGGAGGCGACCGAGCGAGCGATTGCGGCGAGACGGCGTGGGAAGGGAGAGGGAGGCAGAGCACAACTCGCCAAGGAAGAAGAGGAGAGAGAGAAAGAGACTGGATGGATGGATTGCTCCGCAAGAAGGTGGTGGGTCTTGGGCCGGAAATCTGGCCCATCTGTTATTGGGTCAGCCCATGACTCACCCACCTCCCCGTCACGTCGTCTTCCTCCTCATAACTTCTTCCCCACGGGCCAACGGCTGCGCGTCTTCCCGTTCGTCCTCCTGTCCGGTCCGAGTCCCTCTGACGACGCGACTTTCCCCACGCCGGGATCGAGCTCCGGGGAGGGGAGCTGCGAGCTGGTACGTACGCTTGATTTCTTCCCTTGCCACCGCGATATTCCGATGTATCCGTGATGTGTCGTTCATGGGTAGATCGGCTAGGGATTTGGCGGCGTTGAGGAAAGCGATGGCTGCCGGGTGGGGGGAATTGTTGTATTAGACTCTCGAAGCTGATATCTGGTGTGGATTTGCGGTGGAAGCCATGGTCGGAGGCCCAGTGCCTTCCGGGAGTTGTTGGGTTATCGGGAGCCCGGAGGGCAGTGCGGCTCGCCGACTGCTGCCATGATCCCCGTCGGCAAAATCTCCAGATTGGGGGAGATGGGGGGTAGGAACCATTTGGATTAGTAGTGTATACACGGGGTTTCGTTTATTATATTTAGAGCGCTCTACATGTAGACAGCACACAGCAGCTTTAACGTATGGATGGTGTATCGCAGGGAATGTATCTCGAAGACATTGGATTAGGCTATTATTACATTTAGAGAACCAGATTGGGTTTGCGATAACTAGAAATTGAGTCTGTTATGAATTTATTGATGGAGCGGACAGGGAATTACGATTACTATCTGTTTAGCTTTTCAGTTGTGAATGATGATTATTTCAATTTAGCTAATCAAGGTTCCTCAATCAAACCGTTCTAACTTTTTCTATTTATGCTCTTGGTTACATTTTGACAGAAACACTTTGTCATATCAGTCAACAGTAGAGAGGAGACGAG</a:t>
            </a:r>
          </a:p>
        </p:txBody>
      </p:sp>
      <p:sp>
        <p:nvSpPr>
          <p:cNvPr id="5" name="文本框 12">
            <a:extLst>
              <a:ext uri="{FF2B5EF4-FFF2-40B4-BE49-F238E27FC236}">
                <a16:creationId xmlns:a16="http://schemas.microsoft.com/office/drawing/2014/main" id="{19A9E691-DB7B-4B8C-96A5-C1CAC57EAD29}"/>
              </a:ext>
            </a:extLst>
          </p:cNvPr>
          <p:cNvSpPr txBox="1"/>
          <p:nvPr/>
        </p:nvSpPr>
        <p:spPr>
          <a:xfrm>
            <a:off x="265317" y="7625158"/>
            <a:ext cx="61999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tx1"/>
                </a:solidFill>
              </a:rPr>
              <a:t>Figure S5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5119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15</TotalTime>
  <Words>614</Words>
  <Application>Microsoft Office PowerPoint</Application>
  <PresentationFormat>On-screen Show (4:3)</PresentationFormat>
  <Paragraphs>15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ong zhang</cp:lastModifiedBy>
  <cp:revision>44</cp:revision>
  <dcterms:created xsi:type="dcterms:W3CDTF">2018-10-14T18:28:17Z</dcterms:created>
  <dcterms:modified xsi:type="dcterms:W3CDTF">2019-01-14T12:37:05Z</dcterms:modified>
</cp:coreProperties>
</file>